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80672B-076F-4279-9BBF-8C274576790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Slide Number Placeholder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1C2926-5564-4AF2-86CE-CF743BE855E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8B85950-4C8A-47F0-A97A-5DD5EFACB3C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Tab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003E1-7D5E-4570-AF0F-919676A5DE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7D307-061A-414A-A7E1-FECCFE5463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DA01C-7972-4F66-B214-D5D7191E61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42E87-5BE2-485C-8CF1-15801EB527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FE81A4-50C9-4E50-B729-E26D1207DB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D53108-FDC3-48AB-BC78-661B5B8FE1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7739F-EEB5-455D-A795-0958670089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29FEB-A913-40BD-8BF0-A6C5EFC429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FA350-86F9-4A53-931D-CAA1A4354B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01D9A-56DE-42BE-ABDD-C7E172BE74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EB22A-0520-41E7-B787-F915F07515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35CE4-7B90-4AE3-8119-BBCC08742D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87770A-D03B-421A-BF68-B3719915BB2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31760" y="1333440"/>
          <a:ext cx="6624720" cy="2773440"/>
        </p:xfrm>
        <a:graphic>
          <a:graphicData uri="http://schemas.openxmlformats.org/drawingml/2006/table">
            <a:tbl>
              <a:tblPr/>
              <a:tblGrid>
                <a:gridCol w="690480"/>
                <a:gridCol w="754200"/>
                <a:gridCol w="628560"/>
                <a:gridCol w="668520"/>
                <a:gridCol w="876240"/>
                <a:gridCol w="658800"/>
                <a:gridCol w="635040"/>
                <a:gridCol w="874440"/>
                <a:gridCol w="838440"/>
              </a:tblGrid>
              <a:tr h="436680"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 Li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st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-Ra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K3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E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bB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ther Muta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</a:t>
                      </a:r>
                      <a:r>
                        <a:rPr b="1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MEK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M ±SEM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808080"/>
                      </a:solidFill>
                    </a:lnB>
                    <a:noFill/>
                  </a:tcPr>
                </a:tc>
              </a:tr>
              <a:tr h="398520"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27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en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9 (0.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80808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57200"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ROV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en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377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LH1, MSH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 (0.0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58720"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KOV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en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3140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mplifi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c.2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KN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7200"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ro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391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 (0.00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65120"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VCAR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ro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2327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376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60840" bIns="608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Text Box 45"/>
          <p:cNvSpPr/>
          <p:nvPr/>
        </p:nvSpPr>
        <p:spPr>
          <a:xfrm>
            <a:off x="4940280" y="8761320"/>
            <a:ext cx="20685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ffffff"/>
                </a:solidFill>
                <a:latin typeface="Calibri"/>
              </a:rPr>
              <a:t>COSMIC database (Sanger.co.uk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4"/>
          <p:cNvSpPr/>
          <p:nvPr/>
        </p:nvSpPr>
        <p:spPr>
          <a:xfrm>
            <a:off x="76320" y="4191120"/>
            <a:ext cx="6858000" cy="176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utation data were obtained from the catalog of somatic mutations in cancer database, COSMIC (http://www.sanger.ac.uk/genetics/CGP/cosmic/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stology data was obtained from ATCC and COSMIC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rresponds to doses that result in 50% growth inhibition, relative to vehicle-only treated control cells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ta are expressed as mean (±SEM), determined for a range of drug concentration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N: unknown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: wild 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17T20:17:40Z</dcterms:created>
  <dc:creator>Hayley</dc:creator>
  <dc:description/>
  <dc:language>en-US</dc:language>
  <cp:lastModifiedBy>Hayley</cp:lastModifiedBy>
  <dcterms:modified xsi:type="dcterms:W3CDTF">2013-01-09T20:57:54Z</dcterms:modified>
  <cp:revision>10</cp:revision>
  <dc:subject/>
  <dc:title>Slide 1</dc:title>
</cp:coreProperties>
</file>